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AntonsFiveHundredWD2010:Users:asg:Desktop:openbiologymay2016:taqman(5-16-16)%20ChinYo%20Graph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AntonsFiveHundredWD2010:Users:asg:Desktop:openbiologymay2016:taqman(5-16-16)%20ChinYo%20Graph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7603026894365"/>
          <c:y val="8.5148514851485099E-2"/>
          <c:w val="0.84281750495473795"/>
          <c:h val="0.77982263974428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C$15:$C$1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316.7836077902739</c:v>
                  </c:pt>
                </c:numCache>
              </c:numRef>
            </c:plus>
            <c:minus>
              <c:numRef>
                <c:f>Sheet1!$C$15:$C$1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316.7836077902739</c:v>
                  </c:pt>
                </c:numCache>
              </c:numRef>
            </c:minus>
          </c:errBars>
          <c:cat>
            <c:strRef>
              <c:f>Sheet1!$A$15:$A$16</c:f>
              <c:strCache>
                <c:ptCount val="2"/>
                <c:pt idx="0">
                  <c:v>T47d sport6 ctr</c:v>
                </c:pt>
                <c:pt idx="1">
                  <c:v>T47D BC041455</c:v>
                </c:pt>
              </c:strCache>
            </c:strRef>
          </c:cat>
          <c:val>
            <c:numRef>
              <c:f>Sheet1!$B$15:$B$16</c:f>
              <c:numCache>
                <c:formatCode>General</c:formatCode>
                <c:ptCount val="2"/>
                <c:pt idx="0">
                  <c:v>1</c:v>
                </c:pt>
                <c:pt idx="1">
                  <c:v>1571.143580976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82-45DB-8911-DA23F85A8E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63663768"/>
        <c:axId val="442997848"/>
      </c:barChart>
      <c:catAx>
        <c:axId val="46366376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42997848"/>
        <c:crosses val="autoZero"/>
        <c:auto val="1"/>
        <c:lblAlgn val="ctr"/>
        <c:lblOffset val="100"/>
        <c:noMultiLvlLbl val="0"/>
      </c:catAx>
      <c:valAx>
        <c:axId val="442997848"/>
        <c:scaling>
          <c:logBase val="1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4636637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C$38:$C$3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910.3309151529711</c:v>
                  </c:pt>
                </c:numCache>
              </c:numRef>
            </c:plus>
            <c:minus>
              <c:numRef>
                <c:f>Sheet1!$C$38:$C$39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910.3309151529711</c:v>
                  </c:pt>
                </c:numCache>
              </c:numRef>
            </c:minus>
          </c:errBars>
          <c:cat>
            <c:strRef>
              <c:f>Sheet1!$A$38:$A$39</c:f>
              <c:strCache>
                <c:ptCount val="2"/>
                <c:pt idx="0">
                  <c:v>MCF7 sport6 ctr</c:v>
                </c:pt>
                <c:pt idx="1">
                  <c:v>MCF7 BC041455</c:v>
                </c:pt>
              </c:strCache>
            </c:strRef>
          </c:cat>
          <c:val>
            <c:numRef>
              <c:f>Sheet1!$B$38:$B$39</c:f>
              <c:numCache>
                <c:formatCode>General</c:formatCode>
                <c:ptCount val="2"/>
                <c:pt idx="0">
                  <c:v>1</c:v>
                </c:pt>
                <c:pt idx="1">
                  <c:v>1961.82249997456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E1-407B-B346-2BDAAF5EDB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3148648"/>
        <c:axId val="443244216"/>
      </c:barChart>
      <c:catAx>
        <c:axId val="44314864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43244216"/>
        <c:crosses val="autoZero"/>
        <c:auto val="1"/>
        <c:lblAlgn val="ctr"/>
        <c:lblOffset val="100"/>
        <c:noMultiLvlLbl val="0"/>
      </c:catAx>
      <c:valAx>
        <c:axId val="443244216"/>
        <c:scaling>
          <c:logBase val="1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443148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AE900-8F4A-854E-ADE9-ADACF64CC621}" type="datetimeFigureOut">
              <a:rPr lang="en-US" smtClean="0"/>
              <a:pPr/>
              <a:t>1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4EB5D-F8FC-5D49-A2B1-B013343F35F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428279"/>
            <a:ext cx="7772400" cy="546425"/>
          </a:xfrm>
        </p:spPr>
        <p:txBody>
          <a:bodyPr>
            <a:normAutofit fontScale="90000"/>
          </a:bodyPr>
          <a:lstStyle/>
          <a:p>
            <a:r>
              <a:rPr lang="en-US" sz="2400" dirty="0"/>
              <a:t>Supplementary Fig. </a:t>
            </a:r>
            <a:r>
              <a:rPr lang="en-US" sz="2400"/>
              <a:t>9:  </a:t>
            </a:r>
            <a:r>
              <a:rPr lang="en-US" sz="2400" dirty="0" err="1"/>
              <a:t>TaqMan</a:t>
            </a:r>
            <a:r>
              <a:rPr lang="en-US" sz="2400" dirty="0"/>
              <a:t> Q-RTPCR quantification of the level of BC041455 or CR593775 </a:t>
            </a:r>
            <a:r>
              <a:rPr lang="en-US" sz="2400" dirty="0" err="1"/>
              <a:t>lncRNA</a:t>
            </a:r>
            <a:r>
              <a:rPr lang="en-US" sz="2400" dirty="0"/>
              <a:t> in cells </a:t>
            </a:r>
            <a:r>
              <a:rPr lang="en-US" sz="2400" dirty="0" err="1"/>
              <a:t>transfected</a:t>
            </a:r>
            <a:r>
              <a:rPr lang="en-US" sz="2400" dirty="0"/>
              <a:t> with plasmids</a:t>
            </a:r>
          </a:p>
        </p:txBody>
      </p:sp>
      <p:graphicFrame>
        <p:nvGraphicFramePr>
          <p:cNvPr id="3" name="Chart 2"/>
          <p:cNvGraphicFramePr/>
          <p:nvPr/>
        </p:nvGraphicFramePr>
        <p:xfrm>
          <a:off x="351193" y="1210995"/>
          <a:ext cx="3694760" cy="256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266279" y="3745617"/>
          <a:ext cx="3864587" cy="256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-696956" y="5109441"/>
            <a:ext cx="2052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ld </a:t>
            </a:r>
            <a:r>
              <a:rPr lang="en-US" dirty="0" err="1"/>
              <a:t>overexpression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-810162" y="2238384"/>
            <a:ext cx="2204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ld </a:t>
            </a:r>
            <a:r>
              <a:rPr lang="en-US" dirty="0" err="1"/>
              <a:t>overexpressio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358497" y="3407063"/>
            <a:ext cx="27051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mpty vector     BC041455 plasmi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78499" y="6157128"/>
            <a:ext cx="2867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mpty vector         BC041455 plasmi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358497" y="1506360"/>
            <a:ext cx="725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-47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358497" y="3898686"/>
            <a:ext cx="798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CF-7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41959" y="2797678"/>
            <a:ext cx="4902041" cy="2936371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7918112" y="2782910"/>
            <a:ext cx="725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-47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554602" y="2797678"/>
            <a:ext cx="798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CF-7</a:t>
            </a:r>
          </a:p>
        </p:txBody>
      </p:sp>
      <p:sp>
        <p:nvSpPr>
          <p:cNvPr id="15" name="Rectangle 14"/>
          <p:cNvSpPr/>
          <p:nvPr/>
        </p:nvSpPr>
        <p:spPr>
          <a:xfrm>
            <a:off x="5400752" y="5972462"/>
            <a:ext cx="3057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Lin et al., Supplementary Fig</a:t>
            </a:r>
            <a:r>
              <a:rPr lang="en-US"/>
              <a:t>. </a:t>
            </a:r>
            <a:r>
              <a:rPr lang="en-US" dirty="0"/>
              <a:t>9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45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Supplementary Fig. 9:  TaqMan Q-RTPCR quantification of the level of BC041455 or CR593775 lncRNA in cells transfected with plasmids</vt:lpstr>
    </vt:vector>
  </TitlesOfParts>
  <Company>Wayne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. 6</dc:title>
  <dc:creator>Anton-Scott Goustin</dc:creator>
  <cp:lastModifiedBy>Erica</cp:lastModifiedBy>
  <cp:revision>16</cp:revision>
  <dcterms:created xsi:type="dcterms:W3CDTF">2016-07-21T09:34:15Z</dcterms:created>
  <dcterms:modified xsi:type="dcterms:W3CDTF">2016-11-20T06:37:36Z</dcterms:modified>
</cp:coreProperties>
</file>